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avi" ContentType="video/avi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fi-FI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4" d="100"/>
          <a:sy n="84" d="100"/>
        </p:scale>
        <p:origin x="-1450" y="-67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fi-FI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fi-FI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FE9980-6D51-45B3-8198-322953164927}" type="datetimeFigureOut">
              <a:rPr lang="fi-FI" smtClean="0"/>
              <a:t>16.9.2016</a:t>
            </a:fld>
            <a:endParaRPr lang="fi-F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57CC9C-79A8-4250-B45F-70379E7B43C2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22339387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fi-FI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i-FI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FE9980-6D51-45B3-8198-322953164927}" type="datetimeFigureOut">
              <a:rPr lang="fi-FI" smtClean="0"/>
              <a:t>16.9.2016</a:t>
            </a:fld>
            <a:endParaRPr lang="fi-F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57CC9C-79A8-4250-B45F-70379E7B43C2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40850036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fi-FI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i-FI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FE9980-6D51-45B3-8198-322953164927}" type="datetimeFigureOut">
              <a:rPr lang="fi-FI" smtClean="0"/>
              <a:t>16.9.2016</a:t>
            </a:fld>
            <a:endParaRPr lang="fi-F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57CC9C-79A8-4250-B45F-70379E7B43C2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891773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fi-FI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i-FI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FE9980-6D51-45B3-8198-322953164927}" type="datetimeFigureOut">
              <a:rPr lang="fi-FI" smtClean="0"/>
              <a:t>16.9.2016</a:t>
            </a:fld>
            <a:endParaRPr lang="fi-F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57CC9C-79A8-4250-B45F-70379E7B43C2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38895665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fi-FI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FE9980-6D51-45B3-8198-322953164927}" type="datetimeFigureOut">
              <a:rPr lang="fi-FI" smtClean="0"/>
              <a:t>16.9.2016</a:t>
            </a:fld>
            <a:endParaRPr lang="fi-F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57CC9C-79A8-4250-B45F-70379E7B43C2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5018025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fi-FI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i-FI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i-FI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FE9980-6D51-45B3-8198-322953164927}" type="datetimeFigureOut">
              <a:rPr lang="fi-FI" smtClean="0"/>
              <a:t>16.9.2016</a:t>
            </a:fld>
            <a:endParaRPr lang="fi-FI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57CC9C-79A8-4250-B45F-70379E7B43C2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27327125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fi-FI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i-FI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i-FI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FE9980-6D51-45B3-8198-322953164927}" type="datetimeFigureOut">
              <a:rPr lang="fi-FI" smtClean="0"/>
              <a:t>16.9.2016</a:t>
            </a:fld>
            <a:endParaRPr lang="fi-FI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57CC9C-79A8-4250-B45F-70379E7B43C2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30343377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fi-FI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FE9980-6D51-45B3-8198-322953164927}" type="datetimeFigureOut">
              <a:rPr lang="fi-FI" smtClean="0"/>
              <a:t>16.9.2016</a:t>
            </a:fld>
            <a:endParaRPr lang="fi-FI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57CC9C-79A8-4250-B45F-70379E7B43C2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24911228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FE9980-6D51-45B3-8198-322953164927}" type="datetimeFigureOut">
              <a:rPr lang="fi-FI" smtClean="0"/>
              <a:t>16.9.2016</a:t>
            </a:fld>
            <a:endParaRPr lang="fi-FI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57CC9C-79A8-4250-B45F-70379E7B43C2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33248697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fi-FI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i-FI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FE9980-6D51-45B3-8198-322953164927}" type="datetimeFigureOut">
              <a:rPr lang="fi-FI" smtClean="0"/>
              <a:t>16.9.2016</a:t>
            </a:fld>
            <a:endParaRPr lang="fi-FI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57CC9C-79A8-4250-B45F-70379E7B43C2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24035264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fi-FI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i-FI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FE9980-6D51-45B3-8198-322953164927}" type="datetimeFigureOut">
              <a:rPr lang="fi-FI" smtClean="0"/>
              <a:t>16.9.2016</a:t>
            </a:fld>
            <a:endParaRPr lang="fi-FI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57CC9C-79A8-4250-B45F-70379E7B43C2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33296001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fi-FI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i-FI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FE9980-6D51-45B3-8198-322953164927}" type="datetimeFigureOut">
              <a:rPr lang="fi-FI" smtClean="0"/>
              <a:t>16.9.2016</a:t>
            </a:fld>
            <a:endParaRPr lang="fi-F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i-F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57CC9C-79A8-4250-B45F-70379E7B43C2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29059387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i-FI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6.xml"/><Relationship Id="rId2" Type="http://schemas.openxmlformats.org/officeDocument/2006/relationships/video" Target="../media/media1.avi"/><Relationship Id="rId1" Type="http://schemas.microsoft.com/office/2007/relationships/media" Target="../media/media1.avi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l"/>
            <a:r>
              <a:rPr lang="en-US" sz="1200" dirty="0" smtClean="0"/>
              <a:t>Additional file 9. </a:t>
            </a:r>
            <a:br>
              <a:rPr lang="en-US" sz="1200" dirty="0" smtClean="0"/>
            </a:br>
            <a:r>
              <a:rPr lang="en-US" sz="1200" dirty="0" smtClean="0"/>
              <a:t>Time-lapse video of wildtype A7r5 vascular smooth muscle cell contraction induced with 100 nM vasopressin perfusion. Images were captured every 15 seconds and contraction was monitored for a total of 35 minutes. </a:t>
            </a:r>
            <a:endParaRPr lang="en-US" sz="1200" dirty="0"/>
          </a:p>
        </p:txBody>
      </p:sp>
      <p:pic>
        <p:nvPicPr>
          <p:cNvPr id="5" name="Supplementary file 9_contraction.avi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1646238" y="1233488"/>
            <a:ext cx="5851525" cy="438943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47945257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5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4</Words>
  <Application>Microsoft Office PowerPoint</Application>
  <PresentationFormat>On-screen Show (4:3)</PresentationFormat>
  <Paragraphs>1</Paragraphs>
  <Slides>1</Slides>
  <Notes>0</Notes>
  <HiddenSlides>0</HiddenSlides>
  <MMClips>1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Additional file 9.  Time-lapse video of wildtype A7r5 vascular smooth muscle cell contraction induced with 100 nM vasopressin perfusion. Images were captured every 15 seconds and contraction was monitored for a total of 35 minutes. </vt:lpstr>
    </vt:vector>
  </TitlesOfParts>
  <Company>University of Turku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dditional file 9.  Time-lapse video of wildtype A7r5 vascular smooth muscle cell contraction induced with 100 nM vasopressin perfusion. Images were captured every 15 seconds and contraction was monitored for a total of 35 minutes. </dc:title>
  <dc:creator>Anna Huhtinen</dc:creator>
  <cp:lastModifiedBy>Anna Huhtinen</cp:lastModifiedBy>
  <cp:revision>1</cp:revision>
  <dcterms:created xsi:type="dcterms:W3CDTF">2016-09-16T07:56:19Z</dcterms:created>
  <dcterms:modified xsi:type="dcterms:W3CDTF">2016-09-16T08:01:33Z</dcterms:modified>
</cp:coreProperties>
</file>